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5840"/>
  </p:normalViewPr>
  <p:slideViewPr>
    <p:cSldViewPr snapToGrid="0">
      <p:cViewPr>
        <p:scale>
          <a:sx n="103" d="100"/>
          <a:sy n="103" d="100"/>
        </p:scale>
        <p:origin x="176" y="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F201FC-7268-4B41-7254-BC005DBD35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C53059-C4E5-19C1-984F-4EEF48FB13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048A3-450C-14CE-20AC-6FCCE837B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FCFF0D-2662-6E60-450C-FFF382B1A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37775-932A-27B8-2CB5-6967181BE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628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9FC2F-371F-45CB-0FD0-CD102C749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4D934E-466F-3491-4A31-D53AE994D7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97D5A5-03F9-4239-7E5C-D927BE3F9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52DC55-39F3-4AC9-B881-EBCD77D5D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B197F0-FAEB-771D-72E0-5FA171234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431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3E1B10-B775-D64D-2C9E-8EFE388202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028CA1-AB9F-9AB0-C28B-F6C80ADB2F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04AD61-392D-1DC6-8FF7-245E12049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731D1-889D-D759-FDD4-920ED4414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FE0AF2-7B89-D6D1-B4F3-66E56370A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127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2788C-2043-2DC5-44C9-730A509F8F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2D7FFE-932D-B41C-959E-FB0B9B109A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167EFD-7CBC-99D4-688A-BCE67DFEB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5453C1-DD27-257C-D0AD-134A2EBF7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2A2C29-A012-C963-89B1-3D811CE39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2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9B448-B371-9EF8-DCBE-C89EDC8E9F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42C8AE-BC3D-C107-E498-3109A2874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055CC-D4C7-AE59-1627-6FCC9612C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EDDC1F-75AC-19D8-3DB4-E40E1700C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8A538-2BED-A466-A76F-0906ACF15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531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04363-3238-B48B-5AC0-80787C6A16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92419C-86C8-036E-1C1C-6E7015223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B2704B-12F9-9046-0669-8FC6B72929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8A0A69-C512-1B26-0569-67774F77C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651631-81D8-0CA7-E521-134C2BD68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C00E8-92EA-A27D-362B-36EF4F982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667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8EE63-95BA-5B2B-2188-A649286B8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5D02BB-281E-976F-57AA-E08A53E1DC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751321-0C97-5396-4F70-657BF38389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BCF238-49B7-2671-34A8-1E1454CA4E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CA2096-EBA7-DBC9-CAC2-C74AFFDC02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EE3A0A-DC49-53EB-3750-409398091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017713-6890-AE5B-C049-28D6ABE91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6DA3D0-D62E-8720-AE58-7EA033701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602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59565-7059-CE30-0636-88A9A623C9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CC4E70-CF78-D384-760C-90821FE7B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7E8E04-3DF3-D565-FB0C-131027B9E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BC7B93-C17B-EBA9-F50D-2BAD157AD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18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363F35-152E-02D1-1E87-BE55D1130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F66B42-C5A1-70F2-C2E6-5574B0DF2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30A556-4099-4382-804E-371943EAE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42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6B52C9-ABF5-E620-BAE7-95340F500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B4C26-68C6-6C95-72AC-E148FEB10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97CFC4-FC09-E299-8644-150543015D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EA0AE4-8CCB-2516-6DCB-CA5EA5D7A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2CC0F2-4D8D-BA29-4CD8-734BF2E9D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2800A1-80E8-BC29-3F34-D4FC40056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452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13D74-19BB-6835-9889-EED60147F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0CF295-63F7-E6DF-80DA-EAE2D26EF2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B0173C-C09F-E8D0-675C-44B5BD0F3B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5FD883-6A1F-4BFC-FF45-C6AD600AC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E36BD7-DF59-A0E9-D169-79880E90B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E0BE3F-9522-D687-D891-B77246D93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055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D6F87C2-633A-0CC8-AAE9-46068E2CF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AB4F65-FA0D-DDC1-F146-F9564458D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A146B-82A7-D7B9-FCCE-CA4623F3BE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AE06C-B670-FC4B-9CA8-8C3533890D7B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46C203-40FE-EABB-BFC1-CF8284FA59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9A7F08-DB51-D193-BAEE-C184ABC58E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9CBBD-537F-D640-8045-37D8B8B09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62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E4E8A27-478C-AAF0-7FD3-1FDD6567BA11}"/>
              </a:ext>
            </a:extLst>
          </p:cNvPr>
          <p:cNvSpPr txBox="1"/>
          <p:nvPr/>
        </p:nvSpPr>
        <p:spPr>
          <a:xfrm>
            <a:off x="0" y="0"/>
            <a:ext cx="123729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a: Variability in cortical thickness calculated by </a:t>
            </a:r>
            <a:r>
              <a:rPr lang="en-US" dirty="0" err="1"/>
              <a:t>FreeSurfer</a:t>
            </a:r>
            <a:r>
              <a:rPr lang="en-US" dirty="0"/>
              <a:t> between two sessions for each scanner calculated as 100* (test-retest)/mean(test, retest)</a:t>
            </a:r>
          </a:p>
        </p:txBody>
      </p:sp>
      <p:pic>
        <p:nvPicPr>
          <p:cNvPr id="4" name="Picture 3" descr="A screen shot of a computer screen&#10;&#10;Description automatically generated">
            <a:extLst>
              <a:ext uri="{FF2B5EF4-FFF2-40B4-BE49-F238E27FC236}">
                <a16:creationId xmlns:a16="http://schemas.microsoft.com/office/drawing/2014/main" id="{839921C6-7146-160F-E347-8658484C85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316" y="965199"/>
            <a:ext cx="10568630" cy="5708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249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0BCAE43-BFAD-7712-70C6-CC72EDEEB615}"/>
              </a:ext>
            </a:extLst>
          </p:cNvPr>
          <p:cNvSpPr txBox="1"/>
          <p:nvPr/>
        </p:nvSpPr>
        <p:spPr>
          <a:xfrm>
            <a:off x="0" y="0"/>
            <a:ext cx="123729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b: Variability in cortical volume calculated by </a:t>
            </a:r>
            <a:r>
              <a:rPr lang="en-US" dirty="0" err="1"/>
              <a:t>FreeSurfer</a:t>
            </a:r>
            <a:r>
              <a:rPr lang="en-US" dirty="0"/>
              <a:t> between two sessions for each scanner calculated as 100* (test-retest)/mean(test, retest)</a:t>
            </a:r>
          </a:p>
        </p:txBody>
      </p:sp>
      <p:pic>
        <p:nvPicPr>
          <p:cNvPr id="3" name="Picture 2" descr="A colorful lines on a black background&#10;&#10;Description automatically generated">
            <a:extLst>
              <a:ext uri="{FF2B5EF4-FFF2-40B4-BE49-F238E27FC236}">
                <a16:creationId xmlns:a16="http://schemas.microsoft.com/office/drawing/2014/main" id="{8E055D93-07F1-7416-34FE-074DA68092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3580" y="927957"/>
            <a:ext cx="8643036" cy="5811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605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58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jiha Bano</dc:creator>
  <cp:lastModifiedBy>Wajiha Bano</cp:lastModifiedBy>
  <cp:revision>2</cp:revision>
  <dcterms:created xsi:type="dcterms:W3CDTF">2023-05-06T04:41:33Z</dcterms:created>
  <dcterms:modified xsi:type="dcterms:W3CDTF">2024-02-20T20:14:22Z</dcterms:modified>
</cp:coreProperties>
</file>